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1E951D-617F-4678-B773-8D5894BF11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670E9-F971-46B7-B6E7-A5A1635CF2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AD712-6DBD-441F-9CBB-E065A1C004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C6981-2E27-41D8-8C53-5783EA27E9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7ACE1-0E28-4510-995D-4714095C1D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C87C5-CD4A-485E-A03D-84D8CC2E97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509A27-2326-498A-85F2-4860C908E5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FC0B4-B6CA-41F2-A430-70E40D0D09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D178A-DB4A-4EAB-B111-1C5924F29C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2565B-61A7-4016-BC5E-18D316B8F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E8F1B-B594-4968-84FA-456BA03B7E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43735-E234-4069-94EB-3241C43FAC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v-S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1AF368-2074-4A64-B96C-D1392B65B9F3}" type="slidenum">
              <a:rPr b="0" lang="sv-S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5"/>
          <p:cNvSpPr/>
          <p:nvPr/>
        </p:nvSpPr>
        <p:spPr>
          <a:xfrm>
            <a:off x="388800" y="7272360"/>
            <a:ext cx="5964480" cy="69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100" spc="-1" strike="noStrike">
                <a:solidFill>
                  <a:srgbClr val="000000"/>
                </a:solidFill>
                <a:latin typeface="Arial"/>
              </a:rPr>
              <a:t>Supporting information Figure S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xamples of a-CGH profiles showing loss of 16q12.1-ter in case 1, loss of 11q22.1-qter in case 27P, gain of 14q11.1-32.31 in case 32 and gains of 14q11.2 and q32.2-qter in case 28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9" descr=""/>
          <p:cNvPicPr/>
          <p:nvPr/>
        </p:nvPicPr>
        <p:blipFill>
          <a:blip r:embed="rId1"/>
          <a:stretch/>
        </p:blipFill>
        <p:spPr>
          <a:xfrm>
            <a:off x="1260360" y="576360"/>
            <a:ext cx="5121360" cy="140328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29"/>
          <p:cNvSpPr/>
          <p:nvPr/>
        </p:nvSpPr>
        <p:spPr>
          <a:xfrm>
            <a:off x="474480" y="11541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"/>
          <p:cNvSpPr/>
          <p:nvPr/>
        </p:nvSpPr>
        <p:spPr>
          <a:xfrm>
            <a:off x="294480" y="75564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Chr. 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38"/>
          <p:cNvSpPr/>
          <p:nvPr/>
        </p:nvSpPr>
        <p:spPr>
          <a:xfrm>
            <a:off x="5646600" y="3097080"/>
            <a:ext cx="435240" cy="27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37" descr=""/>
          <p:cNvPicPr/>
          <p:nvPr/>
        </p:nvPicPr>
        <p:blipFill>
          <a:blip r:embed="rId2"/>
          <a:stretch/>
        </p:blipFill>
        <p:spPr>
          <a:xfrm>
            <a:off x="934920" y="4067280"/>
            <a:ext cx="5418360" cy="1211040"/>
          </a:xfrm>
          <a:prstGeom prst="rect">
            <a:avLst/>
          </a:prstGeom>
          <a:ln w="0">
            <a:noFill/>
          </a:ln>
        </p:spPr>
      </p:pic>
      <p:sp>
        <p:nvSpPr>
          <p:cNvPr id="47" name="Rectangle 28"/>
          <p:cNvSpPr/>
          <p:nvPr/>
        </p:nvSpPr>
        <p:spPr>
          <a:xfrm>
            <a:off x="439560" y="46832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3"/>
          <a:stretch/>
        </p:blipFill>
        <p:spPr>
          <a:xfrm>
            <a:off x="934920" y="5688000"/>
            <a:ext cx="5418360" cy="121140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31"/>
          <p:cNvSpPr/>
          <p:nvPr/>
        </p:nvSpPr>
        <p:spPr>
          <a:xfrm>
            <a:off x="438840" y="6254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2"/>
          <p:cNvSpPr/>
          <p:nvPr/>
        </p:nvSpPr>
        <p:spPr>
          <a:xfrm>
            <a:off x="294480" y="247032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Chr. 1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3"/>
          <p:cNvSpPr/>
          <p:nvPr/>
        </p:nvSpPr>
        <p:spPr>
          <a:xfrm>
            <a:off x="294480" y="426420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Chr. 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4"/>
          <p:cNvSpPr/>
          <p:nvPr/>
        </p:nvSpPr>
        <p:spPr>
          <a:xfrm>
            <a:off x="294480" y="5832360"/>
            <a:ext cx="60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Chr. 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" name="Group 39"/>
          <p:cNvGrpSpPr/>
          <p:nvPr/>
        </p:nvGrpSpPr>
        <p:grpSpPr>
          <a:xfrm>
            <a:off x="1071720" y="2411280"/>
            <a:ext cx="5292720" cy="1096920"/>
            <a:chOff x="1071720" y="2411280"/>
            <a:chExt cx="5292720" cy="1096920"/>
          </a:xfrm>
        </p:grpSpPr>
        <p:pic>
          <p:nvPicPr>
            <p:cNvPr id="54" name="Picture 2" descr=""/>
            <p:cNvPicPr/>
            <p:nvPr/>
          </p:nvPicPr>
          <p:blipFill>
            <a:blip r:embed="rId4"/>
            <a:stretch/>
          </p:blipFill>
          <p:spPr>
            <a:xfrm>
              <a:off x="1071720" y="2411280"/>
              <a:ext cx="5292720" cy="1096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Rectangle 36"/>
            <p:cNvSpPr/>
            <p:nvPr/>
          </p:nvSpPr>
          <p:spPr>
            <a:xfrm>
              <a:off x="5888520" y="2540160"/>
              <a:ext cx="413640" cy="186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Rectangle 12"/>
          <p:cNvSpPr/>
          <p:nvPr/>
        </p:nvSpPr>
        <p:spPr>
          <a:xfrm>
            <a:off x="397080" y="299880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sv-SE" sz="1000" spc="-1" strike="noStrike">
                <a:solidFill>
                  <a:srgbClr val="000000"/>
                </a:solidFill>
                <a:latin typeface="Arial"/>
              </a:rPr>
              <a:t>27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30T10:21:21Z</dcterms:created>
  <dc:creator>Jamileh Hashemi</dc:creator>
  <dc:description/>
  <dc:language>en-US</dc:language>
  <cp:lastModifiedBy>Jamileh</cp:lastModifiedBy>
  <dcterms:modified xsi:type="dcterms:W3CDTF">2013-09-03T20:34:49Z</dcterms:modified>
  <cp:revision>53</cp:revision>
  <dc:subject/>
  <dc:title>PowerPoint Presentation</dc:title>
</cp:coreProperties>
</file>